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78" r:id="rId2"/>
    <p:sldId id="268" r:id="rId3"/>
    <p:sldId id="37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4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PENCER S ERICKSEN" initials="SSE" lastIdx="1" clrIdx="0">
    <p:extLst>
      <p:ext uri="{19B8F6BF-5375-455C-9EA6-DF929625EA0E}">
        <p15:presenceInfo xmlns:p15="http://schemas.microsoft.com/office/powerpoint/2012/main" userId="SPENCER S ERICKSE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4973" autoAdjust="0"/>
    <p:restoredTop sz="69867" autoAdjust="0"/>
  </p:normalViewPr>
  <p:slideViewPr>
    <p:cSldViewPr snapToGrid="0" showGuides="1">
      <p:cViewPr varScale="1">
        <p:scale>
          <a:sx n="79" d="100"/>
          <a:sy n="79" d="100"/>
        </p:scale>
        <p:origin x="996" y="90"/>
      </p:cViewPr>
      <p:guideLst>
        <p:guide orient="horz" pos="2184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CB6B5F-86AE-461F-8AB0-7DDBB352D8DB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44646E-4A24-4E60-996C-4977EB46F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2164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D46195-DED0-4847-8FEC-986B5A4A1F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0C36D3-1DE8-4687-B9C7-5152CE5BB0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B806F9-9B88-4986-ADB1-576F18043D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D9D47B-0595-4FF3-A0CF-8071BE61CF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A002BA-192D-422B-9388-A506ACD68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968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F77170-9724-42AD-8F40-BB2F96A7BA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6DAF55-CC9A-4F23-981D-593F0209A6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C11922-15B8-4668-AC28-98FF4274A9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72B292-E1C2-46C3-A2C1-C49893663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5EF8AB-11C5-4416-A229-80B76CDE9C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345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44C7C59-3B20-42B1-8CBC-D448A3495A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E2B89B-52E2-42DB-9DBD-33C715F64D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2519C8-0493-47B8-BBE6-2F0893326B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195EC3-CD14-4A55-8728-1726F1B7AE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5E0C95-3C89-44AA-969D-041A246CA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108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3529F6-F69B-415E-8F64-B032B08F1D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2E7B63-0E9A-4C56-930E-3A8C76915E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9BABC0-64D7-40A3-8DFE-D626893B55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DD2ED1-150B-4D26-B6C3-D0A1F5B01E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B806C0-581B-4F20-9158-6767C22845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060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7E10D4-6BF3-4C08-A403-96D59E0404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57BE8F-01E3-46FD-B48C-66F0A3F8F6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DA90B8-43AC-4D11-8339-9D24D4A65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610291-05BD-41A6-A8A4-6706EAF110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5501B1-A9DC-4A1D-B857-952F6AB4D1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3806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A85766-2567-4B4C-87E8-BECB9B19B2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364614-3CF2-4E6A-B727-A28FF660F8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933CD1-8E7B-4591-ACE4-8A5B17AD8F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144AC2-74F1-426D-B91B-73092C110D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DE2F4A-FF33-426D-B791-FF9EBB808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5CA4D6-07CD-40EE-95DC-47E206FF85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135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9F72B4-BFF1-41B6-80C1-21931CB11B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B6D0A0-B7A0-4E7F-A8BC-62370CB4F0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B948A0-1FD2-44A9-B153-8578AE02EB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7BC4ABF-3312-460E-AD18-4C9348289D2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7433B5E-82E7-46C6-B55F-C368F1D61B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254A009-DA8F-4950-873F-2939DF7CF6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9CF8142-CE80-4CAC-8578-AAF90CF0BB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6792A27-FCAD-45D4-8BF3-239B025988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803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240504-6C69-4DD8-857D-CA5773AF65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933BD0-49F3-4D0F-8F0A-7D81AF8FE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1EF888C-E284-42B6-B833-F78636BB75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9EDEF84-E322-42D9-BE1C-13ACAC46A6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749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3782D5-D5BE-4491-BB4E-82F775919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6A06B7A-3CB0-4460-87A7-6970211DF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06245F4-8D39-4455-A6F6-294497F0D5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83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A21308-A7EC-4739-914D-298CDB143D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604218-0658-44F6-A2F1-F41546FD2D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8E6DF5-2431-40B5-BFAA-57A6AE8360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EFBB8B-93A6-4670-8ACD-4B7C748346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56AA2E-38D3-4EDD-88A6-7E8BF4BA8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23A034-2E69-4E8E-8A7A-8EB69791E1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288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BCD1BF-F1BB-43DE-A9B9-0ED1735AFF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4D76C24-0F04-4C23-B277-46F87B9A39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696122-FBC4-4A33-880C-EC2A25BAAA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37E941-B190-4D2B-B376-3458E1EF16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3D840B-7664-423C-AF2B-A814614144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63585B-8AFD-4CA8-BB64-3FEE0274A1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452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71938E-49A9-4B5C-88C7-0C2B443077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108E2E-5CE6-43E7-9244-384CE31424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979B12-140A-4D95-B6E9-1EB7BB94BF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8EF12-3B0F-4779-AF72-0DC2CB2FA6D2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23B1EF-FB1C-4EAE-AACA-8B27338A5F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2D546E-1CBC-4768-B450-CA29BE92A7C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1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tructure of a chemical formula&#10;&#10;Description automatically generated">
            <a:extLst>
              <a:ext uri="{FF2B5EF4-FFF2-40B4-BE49-F238E27FC236}">
                <a16:creationId xmlns:a16="http://schemas.microsoft.com/office/drawing/2014/main" id="{8154AEA5-A235-BDD9-4435-BF2A8A9CBFC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5871" y="3755158"/>
            <a:ext cx="3017520" cy="301752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 descr="A structure of a chemical formula&#10;&#10;Description automatically generated">
            <a:extLst>
              <a:ext uri="{FF2B5EF4-FFF2-40B4-BE49-F238E27FC236}">
                <a16:creationId xmlns:a16="http://schemas.microsoft.com/office/drawing/2014/main" id="{F57BFE42-BD96-06C8-E971-36669D9C007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33782" y="3755158"/>
            <a:ext cx="3017520" cy="3017520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Picture 8" descr="A structure of a chemical formula&#10;&#10;Description automatically generated">
            <a:extLst>
              <a:ext uri="{FF2B5EF4-FFF2-40B4-BE49-F238E27FC236}">
                <a16:creationId xmlns:a16="http://schemas.microsoft.com/office/drawing/2014/main" id="{CF0066EC-0DF5-CF63-166F-A262B6CD666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34302" y="728980"/>
            <a:ext cx="3017520" cy="301752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Picture 10" descr="A structure of a chemical formula&#10;&#10;Description automatically generated">
            <a:extLst>
              <a:ext uri="{FF2B5EF4-FFF2-40B4-BE49-F238E27FC236}">
                <a16:creationId xmlns:a16="http://schemas.microsoft.com/office/drawing/2014/main" id="{60A431A3-42C7-06D6-9D86-A771ABAD322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8480" y="728980"/>
            <a:ext cx="3017520" cy="3017520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Picture 12" descr="A structure of a molecule&#10;&#10;Description automatically generated">
            <a:extLst>
              <a:ext uri="{FF2B5EF4-FFF2-40B4-BE49-F238E27FC236}">
                <a16:creationId xmlns:a16="http://schemas.microsoft.com/office/drawing/2014/main" id="{FB802424-BAD0-4F51-70DF-148AE1E995E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69" y="728980"/>
            <a:ext cx="3017520" cy="3017520"/>
          </a:xfrm>
          <a:prstGeom prst="rect">
            <a:avLst/>
          </a:prstGeom>
          <a:noFill/>
          <a:ln>
            <a:noFill/>
          </a:ln>
        </p:spPr>
      </p:pic>
      <p:pic>
        <p:nvPicPr>
          <p:cNvPr id="15" name="Picture 14" descr="A structure of a chemical formula&#10;&#10;Description automatically generated">
            <a:extLst>
              <a:ext uri="{FF2B5EF4-FFF2-40B4-BE49-F238E27FC236}">
                <a16:creationId xmlns:a16="http://schemas.microsoft.com/office/drawing/2014/main" id="{40C51015-D8C8-1519-9F12-8169D717157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15" y="3755158"/>
            <a:ext cx="3017520" cy="3017520"/>
          </a:xfrm>
          <a:prstGeom prst="rect">
            <a:avLst/>
          </a:prstGeom>
          <a:noFill/>
          <a:ln>
            <a:noFill/>
          </a:ln>
        </p:spPr>
      </p:pic>
      <p:pic>
        <p:nvPicPr>
          <p:cNvPr id="17" name="Picture 16" descr="A structure of a chemical formula&#10;&#10;Description automatically generated">
            <a:extLst>
              <a:ext uri="{FF2B5EF4-FFF2-40B4-BE49-F238E27FC236}">
                <a16:creationId xmlns:a16="http://schemas.microsoft.com/office/drawing/2014/main" id="{36AB22D4-2845-8F1D-97FD-7BE1CC5AD55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8826" y="3755158"/>
            <a:ext cx="3017520" cy="3017520"/>
          </a:xfrm>
          <a:prstGeom prst="rect">
            <a:avLst/>
          </a:prstGeom>
          <a:noFill/>
          <a:ln>
            <a:noFill/>
          </a:ln>
        </p:spPr>
      </p:pic>
      <p:pic>
        <p:nvPicPr>
          <p:cNvPr id="19" name="Picture 18" descr="A structure of a molecule&#10;&#10;Description automatically generated">
            <a:extLst>
              <a:ext uri="{FF2B5EF4-FFF2-40B4-BE49-F238E27FC236}">
                <a16:creationId xmlns:a16="http://schemas.microsoft.com/office/drawing/2014/main" id="{151D42A5-8865-3172-329A-934503BA45B0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6391" y="728980"/>
            <a:ext cx="3017520" cy="301752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055E8F2-32AC-C1DC-3ACB-ACFDC93870A8}"/>
              </a:ext>
            </a:extLst>
          </p:cNvPr>
          <p:cNvSpPr txBox="1"/>
          <p:nvPr/>
        </p:nvSpPr>
        <p:spPr>
          <a:xfrm>
            <a:off x="32617" y="41946"/>
            <a:ext cx="38138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dditional File 7A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“positive bit”: 694 -- methine carbon</a:t>
            </a:r>
          </a:p>
        </p:txBody>
      </p:sp>
    </p:spTree>
    <p:extLst>
      <p:ext uri="{BB962C8B-B14F-4D97-AF65-F5344CB8AC3E}">
        <p14:creationId xmlns:p14="http://schemas.microsoft.com/office/powerpoint/2010/main" val="36435602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 descr="A structure of a molecule&#10;&#10;Description automatically generated">
            <a:extLst>
              <a:ext uri="{FF2B5EF4-FFF2-40B4-BE49-F238E27FC236}">
                <a16:creationId xmlns:a16="http://schemas.microsoft.com/office/drawing/2014/main" id="{5983AC89-D301-5E7C-8389-2921005355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4" y="392025"/>
            <a:ext cx="3017520" cy="3017520"/>
          </a:xfrm>
          <a:prstGeom prst="rect">
            <a:avLst/>
          </a:prstGeom>
          <a:solidFill>
            <a:schemeClr val="tx1"/>
          </a:solidFill>
          <a:ln>
            <a:noFill/>
          </a:ln>
        </p:spPr>
      </p:pic>
      <p:pic>
        <p:nvPicPr>
          <p:cNvPr id="5" name="Picture 4" descr="A diagram of a molecule&#10;&#10;Description automatically generated">
            <a:extLst>
              <a:ext uri="{FF2B5EF4-FFF2-40B4-BE49-F238E27FC236}">
                <a16:creationId xmlns:a16="http://schemas.microsoft.com/office/drawing/2014/main" id="{70AA1A17-5ACB-F2A5-1E34-FFAC8F17194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3286" y="3419273"/>
            <a:ext cx="3017520" cy="3017520"/>
          </a:xfrm>
          <a:prstGeom prst="rect">
            <a:avLst/>
          </a:prstGeom>
          <a:solidFill>
            <a:schemeClr val="tx1"/>
          </a:solidFill>
          <a:ln>
            <a:noFill/>
          </a:ln>
        </p:spPr>
      </p:pic>
      <p:pic>
        <p:nvPicPr>
          <p:cNvPr id="6" name="Picture 5" descr="A structure of a molecule&#10;&#10;Description automatically generated">
            <a:extLst>
              <a:ext uri="{FF2B5EF4-FFF2-40B4-BE49-F238E27FC236}">
                <a16:creationId xmlns:a16="http://schemas.microsoft.com/office/drawing/2014/main" id="{AADEE0DF-0F52-44AE-B52E-64E84B0C26D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25840" y="392024"/>
            <a:ext cx="3017520" cy="3017520"/>
          </a:xfrm>
          <a:prstGeom prst="rect">
            <a:avLst/>
          </a:prstGeom>
          <a:solidFill>
            <a:schemeClr val="tx1"/>
          </a:solidFill>
          <a:ln>
            <a:noFill/>
          </a:ln>
        </p:spPr>
      </p:pic>
      <p:pic>
        <p:nvPicPr>
          <p:cNvPr id="18" name="Picture 17" descr="A diagram of a molecule&#10;&#10;Description automatically generated">
            <a:extLst>
              <a:ext uri="{FF2B5EF4-FFF2-40B4-BE49-F238E27FC236}">
                <a16:creationId xmlns:a16="http://schemas.microsoft.com/office/drawing/2014/main" id="{AA32DAF1-6EEC-C7FB-EB95-2BCBA1FFD84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9834" y="392025"/>
            <a:ext cx="3017520" cy="3017520"/>
          </a:xfrm>
          <a:prstGeom prst="rect">
            <a:avLst/>
          </a:prstGeom>
          <a:solidFill>
            <a:schemeClr val="tx1"/>
          </a:solidFill>
          <a:ln>
            <a:noFill/>
          </a:ln>
        </p:spPr>
      </p:pic>
      <p:pic>
        <p:nvPicPr>
          <p:cNvPr id="19" name="Picture 18" descr="A structure of a chemical formula&#10;&#10;Description automatically generated">
            <a:extLst>
              <a:ext uri="{FF2B5EF4-FFF2-40B4-BE49-F238E27FC236}">
                <a16:creationId xmlns:a16="http://schemas.microsoft.com/office/drawing/2014/main" id="{1F8A50FE-FF43-B51F-9744-AAC80473ABB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55" y="3419273"/>
            <a:ext cx="3017520" cy="3017520"/>
          </a:xfrm>
          <a:prstGeom prst="rect">
            <a:avLst/>
          </a:prstGeom>
          <a:solidFill>
            <a:schemeClr val="tx1"/>
          </a:solidFill>
          <a:ln>
            <a:noFill/>
          </a:ln>
        </p:spPr>
      </p:pic>
      <p:pic>
        <p:nvPicPr>
          <p:cNvPr id="20" name="Picture 19" descr="A structure of a molecule&#10;&#10;Description automatically generated">
            <a:extLst>
              <a:ext uri="{FF2B5EF4-FFF2-40B4-BE49-F238E27FC236}">
                <a16:creationId xmlns:a16="http://schemas.microsoft.com/office/drawing/2014/main" id="{7267F8FC-AE50-C3C7-AF4F-29BB840AB32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0534" y="392025"/>
            <a:ext cx="3017520" cy="3017520"/>
          </a:xfrm>
          <a:prstGeom prst="rect">
            <a:avLst/>
          </a:prstGeom>
          <a:solidFill>
            <a:schemeClr val="tx1"/>
          </a:solidFill>
          <a:ln>
            <a:noFill/>
          </a:ln>
        </p:spPr>
      </p:pic>
      <p:pic>
        <p:nvPicPr>
          <p:cNvPr id="21" name="Picture 20" descr="A structure of a chemical formula&#10;&#10;Description automatically generated">
            <a:extLst>
              <a:ext uri="{FF2B5EF4-FFF2-40B4-BE49-F238E27FC236}">
                <a16:creationId xmlns:a16="http://schemas.microsoft.com/office/drawing/2014/main" id="{63F2C22B-67E9-7527-713F-AB47D482D15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29292" y="3409545"/>
            <a:ext cx="3017520" cy="3017520"/>
          </a:xfrm>
          <a:prstGeom prst="rect">
            <a:avLst/>
          </a:prstGeom>
          <a:solidFill>
            <a:schemeClr val="tx1"/>
          </a:solidFill>
          <a:ln>
            <a:noFill/>
          </a:ln>
        </p:spPr>
      </p:pic>
      <p:pic>
        <p:nvPicPr>
          <p:cNvPr id="23" name="Picture 22" descr="A structure of a chemical formula&#10;&#10;Description automatically generated">
            <a:extLst>
              <a:ext uri="{FF2B5EF4-FFF2-40B4-BE49-F238E27FC236}">
                <a16:creationId xmlns:a16="http://schemas.microsoft.com/office/drawing/2014/main" id="{7190E26F-EAC4-076B-AB11-BB294549570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0534" y="3419273"/>
            <a:ext cx="3017520" cy="3017520"/>
          </a:xfrm>
          <a:prstGeom prst="rect">
            <a:avLst/>
          </a:prstGeom>
          <a:solidFill>
            <a:schemeClr val="tx1"/>
          </a:solidFill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CF116D4-9990-D022-39CC-3C3BE215F83A}"/>
              </a:ext>
            </a:extLst>
          </p:cNvPr>
          <p:cNvSpPr txBox="1"/>
          <p:nvPr/>
        </p:nvSpPr>
        <p:spPr>
          <a:xfrm>
            <a:off x="32617" y="41946"/>
            <a:ext cx="46474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dditional File 7B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“negative bit”: 1917 -- carbonyl substructure</a:t>
            </a:r>
          </a:p>
        </p:txBody>
      </p:sp>
    </p:spTree>
    <p:extLst>
      <p:ext uri="{BB962C8B-B14F-4D97-AF65-F5344CB8AC3E}">
        <p14:creationId xmlns:p14="http://schemas.microsoft.com/office/powerpoint/2010/main" val="42101491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A structure of a chemical formula&#10;&#10;Description automatically generated">
            <a:extLst>
              <a:ext uri="{FF2B5EF4-FFF2-40B4-BE49-F238E27FC236}">
                <a16:creationId xmlns:a16="http://schemas.microsoft.com/office/drawing/2014/main" id="{0C48EA91-C025-D66D-3353-65382E02D4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9892" y="3790801"/>
            <a:ext cx="3017520" cy="3017520"/>
          </a:xfrm>
          <a:prstGeom prst="rect">
            <a:avLst/>
          </a:prstGeom>
          <a:ln>
            <a:noFill/>
          </a:ln>
        </p:spPr>
      </p:pic>
      <p:pic>
        <p:nvPicPr>
          <p:cNvPr id="13" name="Picture 12" descr="A structure of a chemical formula&#10;&#10;Description automatically generated">
            <a:extLst>
              <a:ext uri="{FF2B5EF4-FFF2-40B4-BE49-F238E27FC236}">
                <a16:creationId xmlns:a16="http://schemas.microsoft.com/office/drawing/2014/main" id="{E4AEB84D-9C07-6A48-863A-EE51F42A106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1645" y="759623"/>
            <a:ext cx="3017520" cy="3017520"/>
          </a:xfrm>
          <a:prstGeom prst="rect">
            <a:avLst/>
          </a:prstGeom>
          <a:ln>
            <a:noFill/>
          </a:ln>
        </p:spPr>
      </p:pic>
      <p:pic>
        <p:nvPicPr>
          <p:cNvPr id="14" name="Picture 13" descr="A structure of a molecule&#10;&#10;Description automatically generated">
            <a:extLst>
              <a:ext uri="{FF2B5EF4-FFF2-40B4-BE49-F238E27FC236}">
                <a16:creationId xmlns:a16="http://schemas.microsoft.com/office/drawing/2014/main" id="{9DB42B59-CA5B-EEAD-4011-CDB5CE011BD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1739" y="3790801"/>
            <a:ext cx="3017520" cy="3017520"/>
          </a:xfrm>
          <a:prstGeom prst="rect">
            <a:avLst/>
          </a:prstGeom>
          <a:ln>
            <a:noFill/>
          </a:ln>
        </p:spPr>
      </p:pic>
      <p:pic>
        <p:nvPicPr>
          <p:cNvPr id="12" name="Picture 11" descr="A structure of a molecule&#10;&#10;Description automatically generated">
            <a:extLst>
              <a:ext uri="{FF2B5EF4-FFF2-40B4-BE49-F238E27FC236}">
                <a16:creationId xmlns:a16="http://schemas.microsoft.com/office/drawing/2014/main" id="{FCCDE7BB-6387-20FF-5753-63A5E3D7765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205" y="759623"/>
            <a:ext cx="3017520" cy="3017520"/>
          </a:xfrm>
          <a:prstGeom prst="rect">
            <a:avLst/>
          </a:prstGeom>
          <a:ln>
            <a:noFill/>
          </a:ln>
        </p:spPr>
      </p:pic>
      <p:pic>
        <p:nvPicPr>
          <p:cNvPr id="16" name="Picture 15" descr="A structure of a molecule&#10;&#10;Description automatically generated">
            <a:extLst>
              <a:ext uri="{FF2B5EF4-FFF2-40B4-BE49-F238E27FC236}">
                <a16:creationId xmlns:a16="http://schemas.microsoft.com/office/drawing/2014/main" id="{352BF1EB-011B-3875-D2EE-3CB135F0F69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26994" y="759623"/>
            <a:ext cx="3017520" cy="3017520"/>
          </a:xfrm>
          <a:prstGeom prst="rect">
            <a:avLst/>
          </a:prstGeom>
          <a:ln>
            <a:noFill/>
          </a:ln>
        </p:spPr>
      </p:pic>
      <p:pic>
        <p:nvPicPr>
          <p:cNvPr id="17" name="Picture 16" descr="A structure of a chemical formula&#10;&#10;Description automatically generated">
            <a:extLst>
              <a:ext uri="{FF2B5EF4-FFF2-40B4-BE49-F238E27FC236}">
                <a16:creationId xmlns:a16="http://schemas.microsoft.com/office/drawing/2014/main" id="{4ED94D51-0EA9-E5F3-EC4D-268B58F0147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82" y="3787776"/>
            <a:ext cx="3017520" cy="3017520"/>
          </a:xfrm>
          <a:prstGeom prst="rect">
            <a:avLst/>
          </a:prstGeom>
          <a:ln>
            <a:noFill/>
          </a:ln>
        </p:spPr>
      </p:pic>
      <p:pic>
        <p:nvPicPr>
          <p:cNvPr id="19" name="Picture 18" descr="A structure of a chemical formula&#10;&#10;Description automatically generated">
            <a:extLst>
              <a:ext uri="{FF2B5EF4-FFF2-40B4-BE49-F238E27FC236}">
                <a16:creationId xmlns:a16="http://schemas.microsoft.com/office/drawing/2014/main" id="{7F984961-C6C3-4C03-EE42-73966255196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18132" y="3787776"/>
            <a:ext cx="3017520" cy="3017520"/>
          </a:xfrm>
          <a:prstGeom prst="rect">
            <a:avLst/>
          </a:prstGeom>
          <a:ln>
            <a:noFill/>
          </a:ln>
        </p:spPr>
      </p:pic>
      <p:pic>
        <p:nvPicPr>
          <p:cNvPr id="18" name="Picture 17" descr="A structure of a molecule&#10;&#10;Description automatically generated">
            <a:extLst>
              <a:ext uri="{FF2B5EF4-FFF2-40B4-BE49-F238E27FC236}">
                <a16:creationId xmlns:a16="http://schemas.microsoft.com/office/drawing/2014/main" id="{F99E257D-4EDB-B77C-7DAD-3508A4E582D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82" y="759623"/>
            <a:ext cx="3017520" cy="3017520"/>
          </a:xfrm>
          <a:prstGeom prst="rect">
            <a:avLst/>
          </a:prstGeom>
          <a:ln w="38100"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E9305C8-C9FE-6997-D247-9954A5DB628D}"/>
              </a:ext>
            </a:extLst>
          </p:cNvPr>
          <p:cNvSpPr txBox="1"/>
          <p:nvPr/>
        </p:nvSpPr>
        <p:spPr>
          <a:xfrm>
            <a:off x="32617" y="41946"/>
            <a:ext cx="693863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dditional File 7C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“negative bit”: 1152 -- general secondary amine (frequently amide)</a:t>
            </a:r>
          </a:p>
        </p:txBody>
      </p:sp>
    </p:spTree>
    <p:extLst>
      <p:ext uri="{BB962C8B-B14F-4D97-AF65-F5344CB8AC3E}">
        <p14:creationId xmlns:p14="http://schemas.microsoft.com/office/powerpoint/2010/main" val="42733275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03</TotalTime>
  <Words>38</Words>
  <Application>Microsoft Office PowerPoint</Application>
  <PresentationFormat>Widescreen</PresentationFormat>
  <Paragraphs>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ata Mining Data extraction and mining from PubChem repository</dc:title>
  <dc:creator>SPENCER S ERICKSEN</dc:creator>
  <cp:lastModifiedBy>MANISH S PATANKAR</cp:lastModifiedBy>
  <cp:revision>56</cp:revision>
  <dcterms:created xsi:type="dcterms:W3CDTF">2020-08-07T08:04:12Z</dcterms:created>
  <dcterms:modified xsi:type="dcterms:W3CDTF">2024-04-19T14:54:48Z</dcterms:modified>
</cp:coreProperties>
</file>